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6" r:id="rId2"/>
  </p:sldIdLst>
  <p:sldSz cx="50399950" cy="511921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14" userDrawn="1">
          <p15:clr>
            <a:srgbClr val="A4A3A4"/>
          </p15:clr>
        </p15:guide>
        <p15:guide id="2" pos="1587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思佳 陆" initials="思陆" lastIdx="1" clrIdx="0">
    <p:extLst>
      <p:ext uri="{19B8F6BF-5375-455C-9EA6-DF929625EA0E}">
        <p15:presenceInfo xmlns:p15="http://schemas.microsoft.com/office/powerpoint/2012/main" userId="d036d86b2a8be72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228" autoAdjust="0"/>
    <p:restoredTop sz="87740" autoAdjust="0"/>
  </p:normalViewPr>
  <p:slideViewPr>
    <p:cSldViewPr snapToGrid="0" showGuides="1">
      <p:cViewPr varScale="1">
        <p:scale>
          <a:sx n="13" d="100"/>
          <a:sy n="13" d="100"/>
        </p:scale>
        <p:origin x="2202" y="252"/>
      </p:cViewPr>
      <p:guideLst>
        <p:guide orient="horz" pos="16214"/>
        <p:guide pos="1587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69AB58-2853-4056-96E7-5E9050D1E544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909763" y="1143000"/>
            <a:ext cx="3038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2CABA1-234E-4E89-B26C-4762CA62E4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2166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79996" y="8377972"/>
            <a:ext cx="42839958" cy="17822439"/>
          </a:xfrm>
        </p:spPr>
        <p:txBody>
          <a:bodyPr anchor="b"/>
          <a:lstStyle>
            <a:lvl1pPr algn="ctr">
              <a:defRPr sz="3307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299994" y="26887713"/>
            <a:ext cx="37799963" cy="12359574"/>
          </a:xfrm>
        </p:spPr>
        <p:txBody>
          <a:bodyPr/>
          <a:lstStyle>
            <a:lvl1pPr marL="0" indent="0" algn="ctr">
              <a:buNone/>
              <a:defRPr sz="13228"/>
            </a:lvl1pPr>
            <a:lvl2pPr marL="2519995" indent="0" algn="ctr">
              <a:buNone/>
              <a:defRPr sz="11024"/>
            </a:lvl2pPr>
            <a:lvl3pPr marL="5039990" indent="0" algn="ctr">
              <a:buNone/>
              <a:defRPr sz="9921"/>
            </a:lvl3pPr>
            <a:lvl4pPr marL="7559985" indent="0" algn="ctr">
              <a:buNone/>
              <a:defRPr sz="8819"/>
            </a:lvl4pPr>
            <a:lvl5pPr marL="10079980" indent="0" algn="ctr">
              <a:buNone/>
              <a:defRPr sz="8819"/>
            </a:lvl5pPr>
            <a:lvl6pPr marL="12599975" indent="0" algn="ctr">
              <a:buNone/>
              <a:defRPr sz="8819"/>
            </a:lvl6pPr>
            <a:lvl7pPr marL="15119970" indent="0" algn="ctr">
              <a:buNone/>
              <a:defRPr sz="8819"/>
            </a:lvl7pPr>
            <a:lvl8pPr marL="17639965" indent="0" algn="ctr">
              <a:buNone/>
              <a:defRPr sz="8819"/>
            </a:lvl8pPr>
            <a:lvl9pPr marL="20159960" indent="0" algn="ctr">
              <a:buNone/>
              <a:defRPr sz="881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0497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3236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7467" y="2725506"/>
            <a:ext cx="10867489" cy="4338294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4999" y="2725506"/>
            <a:ext cx="31972468" cy="4338294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8534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3322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749" y="12762493"/>
            <a:ext cx="43469957" cy="21294493"/>
          </a:xfrm>
        </p:spPr>
        <p:txBody>
          <a:bodyPr anchor="b"/>
          <a:lstStyle>
            <a:lvl1pPr>
              <a:defRPr sz="3307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749" y="34258441"/>
            <a:ext cx="43469957" cy="11198271"/>
          </a:xfrm>
        </p:spPr>
        <p:txBody>
          <a:bodyPr/>
          <a:lstStyle>
            <a:lvl1pPr marL="0" indent="0">
              <a:buNone/>
              <a:defRPr sz="13228">
                <a:solidFill>
                  <a:schemeClr val="tx1"/>
                </a:solidFill>
              </a:defRPr>
            </a:lvl1pPr>
            <a:lvl2pPr marL="2519995" indent="0">
              <a:buNone/>
              <a:defRPr sz="11024">
                <a:solidFill>
                  <a:schemeClr val="tx1">
                    <a:tint val="75000"/>
                  </a:schemeClr>
                </a:solidFill>
              </a:defRPr>
            </a:lvl2pPr>
            <a:lvl3pPr marL="5039990" indent="0">
              <a:buNone/>
              <a:defRPr sz="9921">
                <a:solidFill>
                  <a:schemeClr val="tx1">
                    <a:tint val="75000"/>
                  </a:schemeClr>
                </a:solidFill>
              </a:defRPr>
            </a:lvl3pPr>
            <a:lvl4pPr marL="7559985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4pPr>
            <a:lvl5pPr marL="10079980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5pPr>
            <a:lvl6pPr marL="12599975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6pPr>
            <a:lvl7pPr marL="15119970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7pPr>
            <a:lvl8pPr marL="17639965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8pPr>
            <a:lvl9pPr marL="20159960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256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4996" y="13627530"/>
            <a:ext cx="21419979" cy="324809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4975" y="13627530"/>
            <a:ext cx="21419979" cy="324809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2657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561" y="2725517"/>
            <a:ext cx="43469957" cy="98947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567" y="12549181"/>
            <a:ext cx="21321538" cy="6150160"/>
          </a:xfrm>
        </p:spPr>
        <p:txBody>
          <a:bodyPr anchor="b"/>
          <a:lstStyle>
            <a:lvl1pPr marL="0" indent="0">
              <a:buNone/>
              <a:defRPr sz="13228" b="1"/>
            </a:lvl1pPr>
            <a:lvl2pPr marL="2519995" indent="0">
              <a:buNone/>
              <a:defRPr sz="11024" b="1"/>
            </a:lvl2pPr>
            <a:lvl3pPr marL="5039990" indent="0">
              <a:buNone/>
              <a:defRPr sz="9921" b="1"/>
            </a:lvl3pPr>
            <a:lvl4pPr marL="7559985" indent="0">
              <a:buNone/>
              <a:defRPr sz="8819" b="1"/>
            </a:lvl4pPr>
            <a:lvl5pPr marL="10079980" indent="0">
              <a:buNone/>
              <a:defRPr sz="8819" b="1"/>
            </a:lvl5pPr>
            <a:lvl6pPr marL="12599975" indent="0">
              <a:buNone/>
              <a:defRPr sz="8819" b="1"/>
            </a:lvl6pPr>
            <a:lvl7pPr marL="15119970" indent="0">
              <a:buNone/>
              <a:defRPr sz="8819" b="1"/>
            </a:lvl7pPr>
            <a:lvl8pPr marL="17639965" indent="0">
              <a:buNone/>
              <a:defRPr sz="8819" b="1"/>
            </a:lvl8pPr>
            <a:lvl9pPr marL="20159960" indent="0">
              <a:buNone/>
              <a:defRPr sz="881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567" y="18699341"/>
            <a:ext cx="21321538" cy="2750391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4978" y="12549181"/>
            <a:ext cx="21426543" cy="6150160"/>
          </a:xfrm>
        </p:spPr>
        <p:txBody>
          <a:bodyPr anchor="b"/>
          <a:lstStyle>
            <a:lvl1pPr marL="0" indent="0">
              <a:buNone/>
              <a:defRPr sz="13228" b="1"/>
            </a:lvl1pPr>
            <a:lvl2pPr marL="2519995" indent="0">
              <a:buNone/>
              <a:defRPr sz="11024" b="1"/>
            </a:lvl2pPr>
            <a:lvl3pPr marL="5039990" indent="0">
              <a:buNone/>
              <a:defRPr sz="9921" b="1"/>
            </a:lvl3pPr>
            <a:lvl4pPr marL="7559985" indent="0">
              <a:buNone/>
              <a:defRPr sz="8819" b="1"/>
            </a:lvl4pPr>
            <a:lvl5pPr marL="10079980" indent="0">
              <a:buNone/>
              <a:defRPr sz="8819" b="1"/>
            </a:lvl5pPr>
            <a:lvl6pPr marL="12599975" indent="0">
              <a:buNone/>
              <a:defRPr sz="8819" b="1"/>
            </a:lvl6pPr>
            <a:lvl7pPr marL="15119970" indent="0">
              <a:buNone/>
              <a:defRPr sz="8819" b="1"/>
            </a:lvl7pPr>
            <a:lvl8pPr marL="17639965" indent="0">
              <a:buNone/>
              <a:defRPr sz="8819" b="1"/>
            </a:lvl8pPr>
            <a:lvl9pPr marL="20159960" indent="0">
              <a:buNone/>
              <a:defRPr sz="881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4978" y="18699341"/>
            <a:ext cx="21426543" cy="2750391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8172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8967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8098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561" y="3412808"/>
            <a:ext cx="16255296" cy="11944826"/>
          </a:xfrm>
        </p:spPr>
        <p:txBody>
          <a:bodyPr anchor="b"/>
          <a:lstStyle>
            <a:lvl1pPr>
              <a:defRPr sz="1763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6543" y="7370728"/>
            <a:ext cx="25514975" cy="36379580"/>
          </a:xfrm>
        </p:spPr>
        <p:txBody>
          <a:bodyPr/>
          <a:lstStyle>
            <a:lvl1pPr>
              <a:defRPr sz="17638"/>
            </a:lvl1pPr>
            <a:lvl2pPr>
              <a:defRPr sz="15433"/>
            </a:lvl2pPr>
            <a:lvl3pPr>
              <a:defRPr sz="13228"/>
            </a:lvl3pPr>
            <a:lvl4pPr>
              <a:defRPr sz="11024"/>
            </a:lvl4pPr>
            <a:lvl5pPr>
              <a:defRPr sz="11024"/>
            </a:lvl5pPr>
            <a:lvl6pPr>
              <a:defRPr sz="11024"/>
            </a:lvl6pPr>
            <a:lvl7pPr>
              <a:defRPr sz="11024"/>
            </a:lvl7pPr>
            <a:lvl8pPr>
              <a:defRPr sz="11024"/>
            </a:lvl8pPr>
            <a:lvl9pPr>
              <a:defRPr sz="1102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561" y="15357634"/>
            <a:ext cx="16255296" cy="28451917"/>
          </a:xfrm>
        </p:spPr>
        <p:txBody>
          <a:bodyPr/>
          <a:lstStyle>
            <a:lvl1pPr marL="0" indent="0">
              <a:buNone/>
              <a:defRPr sz="8819"/>
            </a:lvl1pPr>
            <a:lvl2pPr marL="2519995" indent="0">
              <a:buNone/>
              <a:defRPr sz="7717"/>
            </a:lvl2pPr>
            <a:lvl3pPr marL="5039990" indent="0">
              <a:buNone/>
              <a:defRPr sz="6614"/>
            </a:lvl3pPr>
            <a:lvl4pPr marL="7559985" indent="0">
              <a:buNone/>
              <a:defRPr sz="5512"/>
            </a:lvl4pPr>
            <a:lvl5pPr marL="10079980" indent="0">
              <a:buNone/>
              <a:defRPr sz="5512"/>
            </a:lvl5pPr>
            <a:lvl6pPr marL="12599975" indent="0">
              <a:buNone/>
              <a:defRPr sz="5512"/>
            </a:lvl6pPr>
            <a:lvl7pPr marL="15119970" indent="0">
              <a:buNone/>
              <a:defRPr sz="5512"/>
            </a:lvl7pPr>
            <a:lvl8pPr marL="17639965" indent="0">
              <a:buNone/>
              <a:defRPr sz="5512"/>
            </a:lvl8pPr>
            <a:lvl9pPr marL="20159960" indent="0">
              <a:buNone/>
              <a:defRPr sz="55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8459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561" y="3412808"/>
            <a:ext cx="16255296" cy="11944826"/>
          </a:xfrm>
        </p:spPr>
        <p:txBody>
          <a:bodyPr anchor="b"/>
          <a:lstStyle>
            <a:lvl1pPr>
              <a:defRPr sz="1763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6543" y="7370728"/>
            <a:ext cx="25514975" cy="36379580"/>
          </a:xfrm>
        </p:spPr>
        <p:txBody>
          <a:bodyPr anchor="t"/>
          <a:lstStyle>
            <a:lvl1pPr marL="0" indent="0">
              <a:buNone/>
              <a:defRPr sz="17638"/>
            </a:lvl1pPr>
            <a:lvl2pPr marL="2519995" indent="0">
              <a:buNone/>
              <a:defRPr sz="15433"/>
            </a:lvl2pPr>
            <a:lvl3pPr marL="5039990" indent="0">
              <a:buNone/>
              <a:defRPr sz="13228"/>
            </a:lvl3pPr>
            <a:lvl4pPr marL="7559985" indent="0">
              <a:buNone/>
              <a:defRPr sz="11024"/>
            </a:lvl4pPr>
            <a:lvl5pPr marL="10079980" indent="0">
              <a:buNone/>
              <a:defRPr sz="11024"/>
            </a:lvl5pPr>
            <a:lvl6pPr marL="12599975" indent="0">
              <a:buNone/>
              <a:defRPr sz="11024"/>
            </a:lvl6pPr>
            <a:lvl7pPr marL="15119970" indent="0">
              <a:buNone/>
              <a:defRPr sz="11024"/>
            </a:lvl7pPr>
            <a:lvl8pPr marL="17639965" indent="0">
              <a:buNone/>
              <a:defRPr sz="11024"/>
            </a:lvl8pPr>
            <a:lvl9pPr marL="20159960" indent="0">
              <a:buNone/>
              <a:defRPr sz="1102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561" y="15357634"/>
            <a:ext cx="16255296" cy="28451917"/>
          </a:xfrm>
        </p:spPr>
        <p:txBody>
          <a:bodyPr/>
          <a:lstStyle>
            <a:lvl1pPr marL="0" indent="0">
              <a:buNone/>
              <a:defRPr sz="8819"/>
            </a:lvl1pPr>
            <a:lvl2pPr marL="2519995" indent="0">
              <a:buNone/>
              <a:defRPr sz="7717"/>
            </a:lvl2pPr>
            <a:lvl3pPr marL="5039990" indent="0">
              <a:buNone/>
              <a:defRPr sz="6614"/>
            </a:lvl3pPr>
            <a:lvl4pPr marL="7559985" indent="0">
              <a:buNone/>
              <a:defRPr sz="5512"/>
            </a:lvl4pPr>
            <a:lvl5pPr marL="10079980" indent="0">
              <a:buNone/>
              <a:defRPr sz="5512"/>
            </a:lvl5pPr>
            <a:lvl6pPr marL="12599975" indent="0">
              <a:buNone/>
              <a:defRPr sz="5512"/>
            </a:lvl6pPr>
            <a:lvl7pPr marL="15119970" indent="0">
              <a:buNone/>
              <a:defRPr sz="5512"/>
            </a:lvl7pPr>
            <a:lvl8pPr marL="17639965" indent="0">
              <a:buNone/>
              <a:defRPr sz="5512"/>
            </a:lvl8pPr>
            <a:lvl9pPr marL="20159960" indent="0">
              <a:buNone/>
              <a:defRPr sz="55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4806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4997" y="2725517"/>
            <a:ext cx="43469957" cy="98947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4997" y="13627530"/>
            <a:ext cx="43469957" cy="324809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4996" y="47447516"/>
            <a:ext cx="11339989" cy="27255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7ABC3-98B9-4675-B5C7-C4A836183231}" type="datetimeFigureOut">
              <a:rPr lang="zh-CN" altLang="en-US" smtClean="0"/>
              <a:t>2025/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4984" y="47447516"/>
            <a:ext cx="17009983" cy="27255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4965" y="47447516"/>
            <a:ext cx="11339989" cy="27255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934C57-57F6-446E-B97B-2DEEAC439A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8998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039990" rtl="0" eaLnBrk="1" latinLnBrk="0" hangingPunct="1">
        <a:lnSpc>
          <a:spcPct val="90000"/>
        </a:lnSpc>
        <a:spcBef>
          <a:spcPct val="0"/>
        </a:spcBef>
        <a:buNone/>
        <a:defRPr sz="242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59997" indent="-1259997" algn="l" defTabSz="5039990" rtl="0" eaLnBrk="1" latinLnBrk="0" hangingPunct="1">
        <a:lnSpc>
          <a:spcPct val="90000"/>
        </a:lnSpc>
        <a:spcBef>
          <a:spcPts val="5512"/>
        </a:spcBef>
        <a:buFont typeface="Arial" panose="020B0604020202020204" pitchFamily="34" charset="0"/>
        <a:buChar char="•"/>
        <a:defRPr sz="15433" kern="1200">
          <a:solidFill>
            <a:schemeClr val="tx1"/>
          </a:solidFill>
          <a:latin typeface="+mn-lt"/>
          <a:ea typeface="+mn-ea"/>
          <a:cs typeface="+mn-cs"/>
        </a:defRPr>
      </a:lvl1pPr>
      <a:lvl2pPr marL="3779992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13228" kern="1200">
          <a:solidFill>
            <a:schemeClr val="tx1"/>
          </a:solidFill>
          <a:latin typeface="+mn-lt"/>
          <a:ea typeface="+mn-ea"/>
          <a:cs typeface="+mn-cs"/>
        </a:defRPr>
      </a:lvl2pPr>
      <a:lvl3pPr marL="6299987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3pPr>
      <a:lvl4pPr marL="8819982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4pPr>
      <a:lvl5pPr marL="11339977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5pPr>
      <a:lvl6pPr marL="13859972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6pPr>
      <a:lvl7pPr marL="16379967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7pPr>
      <a:lvl8pPr marL="18899962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8pPr>
      <a:lvl9pPr marL="21419957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1pPr>
      <a:lvl2pPr marL="2519995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2pPr>
      <a:lvl3pPr marL="503999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3pPr>
      <a:lvl4pPr marL="7559985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4pPr>
      <a:lvl5pPr marL="1007998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5pPr>
      <a:lvl6pPr marL="12599975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6pPr>
      <a:lvl7pPr marL="1511997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7pPr>
      <a:lvl8pPr marL="17639965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8pPr>
      <a:lvl9pPr marL="2015996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BC07ED9-7E88-587E-2039-1E3592483A7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29" t="6196" r="11037" b="2764"/>
          <a:stretch/>
        </p:blipFill>
        <p:spPr>
          <a:xfrm>
            <a:off x="5271250" y="17498752"/>
            <a:ext cx="24054865" cy="1609464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5025274-2EB3-BB48-ED14-D133ABD10C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120" t="2696" r="23315" b="3292"/>
          <a:stretch/>
        </p:blipFill>
        <p:spPr>
          <a:xfrm>
            <a:off x="8210393" y="33528080"/>
            <a:ext cx="19847859" cy="1720263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2FB1FE5C-0F8C-7AAC-9E11-2AFC34B1EFA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5700"/>
          <a:stretch/>
        </p:blipFill>
        <p:spPr>
          <a:xfrm>
            <a:off x="3899832" y="396082"/>
            <a:ext cx="25948798" cy="17202637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2F8331B-26B3-610B-EEA1-2FC36A3CA88B}"/>
              </a:ext>
            </a:extLst>
          </p:cNvPr>
          <p:cNvSpPr txBox="1"/>
          <p:nvPr/>
        </p:nvSpPr>
        <p:spPr>
          <a:xfrm>
            <a:off x="6531246" y="1281636"/>
            <a:ext cx="167914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EB6CD8A-7907-D54F-EEF0-91CB6C1A5EBE}"/>
              </a:ext>
            </a:extLst>
          </p:cNvPr>
          <p:cNvSpPr txBox="1"/>
          <p:nvPr/>
        </p:nvSpPr>
        <p:spPr>
          <a:xfrm>
            <a:off x="6531246" y="19269863"/>
            <a:ext cx="167914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1B25738-FB95-AC04-1793-B83067F32FD9}"/>
              </a:ext>
            </a:extLst>
          </p:cNvPr>
          <p:cNvSpPr txBox="1"/>
          <p:nvPr/>
        </p:nvSpPr>
        <p:spPr>
          <a:xfrm>
            <a:off x="6913618" y="33593394"/>
            <a:ext cx="167914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FA548B6-6754-7B62-01DB-DFE5CA372E6B}"/>
              </a:ext>
            </a:extLst>
          </p:cNvPr>
          <p:cNvSpPr txBox="1"/>
          <p:nvPr/>
        </p:nvSpPr>
        <p:spPr>
          <a:xfrm>
            <a:off x="35792228" y="25370393"/>
            <a:ext cx="13477795" cy="16019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S1 TMC-ingredient-target spot network maps.  A. Traditional Chinese medicine formula Ⅰ. B. Traditional Chinese medicine formula Ⅱ. C. Traditional Chinese medicine formula Ⅲ.</a:t>
            </a:r>
            <a:endParaRPr lang="zh-CN" altLang="en-US" sz="1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9575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044</TotalTime>
  <Words>34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等线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思佳 陆</dc:creator>
  <cp:lastModifiedBy>Princy M</cp:lastModifiedBy>
  <cp:revision>27</cp:revision>
  <dcterms:created xsi:type="dcterms:W3CDTF">2024-04-23T03:23:58Z</dcterms:created>
  <dcterms:modified xsi:type="dcterms:W3CDTF">2025-01-13T12:00:26Z</dcterms:modified>
</cp:coreProperties>
</file>